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5" r:id="rId3"/>
    <p:sldId id="257" r:id="rId4"/>
    <p:sldId id="256" r:id="rId5"/>
    <p:sldId id="258" r:id="rId6"/>
    <p:sldId id="261" r:id="rId7"/>
    <p:sldId id="259" r:id="rId8"/>
    <p:sldId id="260" r:id="rId9"/>
    <p:sldId id="262" r:id="rId10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0" d="100"/>
          <a:sy n="90" d="100"/>
        </p:scale>
        <p:origin x="1244" y="-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995312"/>
            <a:ext cx="5143500" cy="4244622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5"/>
            <a:ext cx="5915025" cy="5071532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6"/>
            <a:ext cx="5915025" cy="266699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82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82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2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3"/>
            <a:ext cx="3471863" cy="8664222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2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2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79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31EB510-1F83-66C4-E522-B0B52F797A72}"/>
              </a:ext>
            </a:extLst>
          </p:cNvPr>
          <p:cNvSpPr txBox="1"/>
          <p:nvPr/>
        </p:nvSpPr>
        <p:spPr>
          <a:xfrm>
            <a:off x="291150" y="91573"/>
            <a:ext cx="6435716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/>
              <a:t>Figure S1. Forest plot showing individual and pooled incremental yield of prenatal sequencing over chromosomal microarray analysis/karyotype from all 155 studies included in this review </a:t>
            </a:r>
          </a:p>
        </p:txBody>
      </p:sp>
      <p:pic>
        <p:nvPicPr>
          <p:cNvPr id="4" name="Picture 3" descr="A black and white image of lines&#10;&#10;AI-generated content may be incorrect.">
            <a:extLst>
              <a:ext uri="{FF2B5EF4-FFF2-40B4-BE49-F238E27FC236}">
                <a16:creationId xmlns:a16="http://schemas.microsoft.com/office/drawing/2014/main" id="{56D33F91-0FA3-E6C8-CBCC-332C026BC3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283" r="9513" b="53031"/>
          <a:stretch>
            <a:fillRect/>
          </a:stretch>
        </p:blipFill>
        <p:spPr>
          <a:xfrm>
            <a:off x="179260" y="553239"/>
            <a:ext cx="6223007" cy="10788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79910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 descr="A black and white image of lines&#10;&#10;AI-generated content may be incorrect.">
            <a:extLst>
              <a:ext uri="{FF2B5EF4-FFF2-40B4-BE49-F238E27FC236}">
                <a16:creationId xmlns:a16="http://schemas.microsoft.com/office/drawing/2014/main" id="{D3260431-F5EF-1D71-8A7A-59C206D61E2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124" r="10148" b="-2"/>
          <a:stretch>
            <a:fillRect/>
          </a:stretch>
        </p:blipFill>
        <p:spPr>
          <a:xfrm>
            <a:off x="211142" y="26426"/>
            <a:ext cx="6141531" cy="11999105"/>
          </a:xfr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A184B9D-C042-11EF-5649-EDFB02938111}"/>
              </a:ext>
            </a:extLst>
          </p:cNvPr>
          <p:cNvSpPr txBox="1"/>
          <p:nvPr/>
        </p:nvSpPr>
        <p:spPr>
          <a:xfrm>
            <a:off x="211142" y="11888574"/>
            <a:ext cx="6435716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/>
              <a:t>Figure S1. (Continued)</a:t>
            </a:r>
          </a:p>
        </p:txBody>
      </p:sp>
    </p:spTree>
    <p:extLst>
      <p:ext uri="{BB962C8B-B14F-4D97-AF65-F5344CB8AC3E}">
        <p14:creationId xmlns:p14="http://schemas.microsoft.com/office/powerpoint/2010/main" val="30407971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2AF49A42-C048-B3DB-14A9-0985757EEB3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rcRect l="-270" t="11808" r="515" b="10332"/>
          <a:stretch>
            <a:fillRect/>
          </a:stretch>
        </p:blipFill>
        <p:spPr>
          <a:xfrm>
            <a:off x="4018" y="561843"/>
            <a:ext cx="6839280" cy="745188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E255B1C-B116-397C-9E99-9A410897331E}"/>
              </a:ext>
            </a:extLst>
          </p:cNvPr>
          <p:cNvSpPr txBox="1"/>
          <p:nvPr/>
        </p:nvSpPr>
        <p:spPr>
          <a:xfrm>
            <a:off x="113270" y="566350"/>
            <a:ext cx="388208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b="1"/>
              <a:t>Central Nervous System</a:t>
            </a:r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5285477-552D-E65B-DF3E-5F94C3F199D3}"/>
              </a:ext>
            </a:extLst>
          </p:cNvPr>
          <p:cNvSpPr txBox="1"/>
          <p:nvPr/>
        </p:nvSpPr>
        <p:spPr>
          <a:xfrm>
            <a:off x="113270" y="7843855"/>
            <a:ext cx="6435716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/>
              <a:t>Figure S2. Forest plot showing individual and pooled incremental yield of prenatal sequencing over chromosomal microarray analysis/karyotype </a:t>
            </a:r>
            <a:r>
              <a:rPr lang="en-US" sz="1200" dirty="0" err="1"/>
              <a:t>analysed</a:t>
            </a:r>
            <a:r>
              <a:rPr lang="en-US" sz="1200" dirty="0"/>
              <a:t> by phenotypic subgroup</a:t>
            </a:r>
          </a:p>
        </p:txBody>
      </p:sp>
    </p:spTree>
    <p:extLst>
      <p:ext uri="{BB962C8B-B14F-4D97-AF65-F5344CB8AC3E}">
        <p14:creationId xmlns:p14="http://schemas.microsoft.com/office/powerpoint/2010/main" val="12632537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graph with numbers and lines&#10;&#10;AI-generated content may be incorrect.">
            <a:extLst>
              <a:ext uri="{FF2B5EF4-FFF2-40B4-BE49-F238E27FC236}">
                <a16:creationId xmlns:a16="http://schemas.microsoft.com/office/drawing/2014/main" id="{6AC21C2C-B000-845B-9D5D-197E1FC816F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202" t="12727" r="9066" b="10802"/>
          <a:stretch>
            <a:fillRect/>
          </a:stretch>
        </p:blipFill>
        <p:spPr>
          <a:xfrm>
            <a:off x="36577" y="3558418"/>
            <a:ext cx="6680296" cy="798530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B1F8DB2-9198-EE4A-E5D6-25EF0CB25C8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8667" b="1096"/>
          <a:stretch>
            <a:fillRect/>
          </a:stretch>
        </p:blipFill>
        <p:spPr>
          <a:xfrm>
            <a:off x="0" y="1073029"/>
            <a:ext cx="6733630" cy="226774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C1F9252-400D-DBA5-DB6F-4E194C649A0B}"/>
              </a:ext>
            </a:extLst>
          </p:cNvPr>
          <p:cNvSpPr txBox="1"/>
          <p:nvPr/>
        </p:nvSpPr>
        <p:spPr>
          <a:xfrm>
            <a:off x="76694" y="839999"/>
            <a:ext cx="388208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b="1" dirty="0"/>
              <a:t>Neuromuscular/Fetal akinesi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BB24B1D-85F0-A0D0-CCE9-15CBCD788FC3}"/>
              </a:ext>
            </a:extLst>
          </p:cNvPr>
          <p:cNvSpPr txBox="1"/>
          <p:nvPr/>
        </p:nvSpPr>
        <p:spPr>
          <a:xfrm>
            <a:off x="54864" y="3340777"/>
            <a:ext cx="388208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b="1"/>
              <a:t>Multisystem</a:t>
            </a:r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62789DC-A5E2-228E-1314-29FB52F33B94}"/>
              </a:ext>
            </a:extLst>
          </p:cNvPr>
          <p:cNvSpPr txBox="1"/>
          <p:nvPr/>
        </p:nvSpPr>
        <p:spPr>
          <a:xfrm>
            <a:off x="76395" y="11558116"/>
            <a:ext cx="6435716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/>
              <a:t>Figure S2. (Continued)</a:t>
            </a:r>
          </a:p>
        </p:txBody>
      </p:sp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EE66863-A1CE-B08C-F52C-8E0BAED6DE88}"/>
              </a:ext>
            </a:extLst>
          </p:cNvPr>
          <p:cNvSpPr txBox="1"/>
          <p:nvPr/>
        </p:nvSpPr>
        <p:spPr>
          <a:xfrm>
            <a:off x="105279" y="587557"/>
            <a:ext cx="388208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b="1" dirty="0"/>
              <a:t>Cardiac</a:t>
            </a:r>
            <a:endParaRPr lang="en-US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1AC3739-CF63-597E-022D-89AD29F06F4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1900" r="9038" b="5320"/>
          <a:stretch>
            <a:fillRect/>
          </a:stretch>
        </p:blipFill>
        <p:spPr>
          <a:xfrm>
            <a:off x="-1" y="8025313"/>
            <a:ext cx="6585967" cy="386188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C8DF039-10E3-5642-8D54-56E48E8DA457}"/>
              </a:ext>
            </a:extLst>
          </p:cNvPr>
          <p:cNvSpPr txBox="1"/>
          <p:nvPr/>
        </p:nvSpPr>
        <p:spPr>
          <a:xfrm>
            <a:off x="105279" y="7726680"/>
            <a:ext cx="388208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b="1" dirty="0"/>
              <a:t>Craniofacial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A2E630A-0185-44EF-C84B-E0C7CAE06DE4}"/>
              </a:ext>
            </a:extLst>
          </p:cNvPr>
          <p:cNvSpPr txBox="1"/>
          <p:nvPr/>
        </p:nvSpPr>
        <p:spPr>
          <a:xfrm>
            <a:off x="145668" y="11887162"/>
            <a:ext cx="6435716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/>
              <a:t>Figure S2. (Continued)</a:t>
            </a:r>
          </a:p>
        </p:txBody>
      </p:sp>
      <p:pic>
        <p:nvPicPr>
          <p:cNvPr id="10" name="Content Placeholder 9">
            <a:extLst>
              <a:ext uri="{FF2B5EF4-FFF2-40B4-BE49-F238E27FC236}">
                <a16:creationId xmlns:a16="http://schemas.microsoft.com/office/drawing/2014/main" id="{3D340F7E-7FA2-06B8-C1A7-D1120427A14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708" r="9164" b="10304"/>
          <a:stretch>
            <a:fillRect/>
          </a:stretch>
        </p:blipFill>
        <p:spPr>
          <a:xfrm>
            <a:off x="-1" y="814739"/>
            <a:ext cx="6540998" cy="66847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56740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68C51962-9C36-9258-B93F-8B0E24427ED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rcRect r="8902"/>
          <a:stretch>
            <a:fillRect/>
          </a:stretch>
        </p:blipFill>
        <p:spPr>
          <a:xfrm>
            <a:off x="0" y="808463"/>
            <a:ext cx="6770681" cy="292432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4036165-F86B-659C-7404-88C699B69E4C}"/>
              </a:ext>
            </a:extLst>
          </p:cNvPr>
          <p:cNvSpPr txBox="1"/>
          <p:nvPr/>
        </p:nvSpPr>
        <p:spPr>
          <a:xfrm>
            <a:off x="114751" y="807123"/>
            <a:ext cx="388208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b="1" dirty="0"/>
              <a:t>Fetal growth restriction</a:t>
            </a:r>
            <a:endParaRPr lang="en-US" sz="1200" dirty="0"/>
          </a:p>
        </p:txBody>
      </p:sp>
      <p:pic>
        <p:nvPicPr>
          <p:cNvPr id="7" name="Picture 6" descr="A screenshot of a graph&#10;&#10;AI-generated content may be incorrect.">
            <a:extLst>
              <a:ext uri="{FF2B5EF4-FFF2-40B4-BE49-F238E27FC236}">
                <a16:creationId xmlns:a16="http://schemas.microsoft.com/office/drawing/2014/main" id="{51C0D415-97E8-861B-828C-A7CF769E0EB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8934"/>
          <a:stretch>
            <a:fillRect/>
          </a:stretch>
        </p:blipFill>
        <p:spPr>
          <a:xfrm>
            <a:off x="-1" y="3572256"/>
            <a:ext cx="6735627" cy="544372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E8CB67B-CA55-7256-C31C-DDC88FD9AAF1}"/>
              </a:ext>
            </a:extLst>
          </p:cNvPr>
          <p:cNvSpPr txBox="1"/>
          <p:nvPr/>
        </p:nvSpPr>
        <p:spPr>
          <a:xfrm>
            <a:off x="114751" y="4021296"/>
            <a:ext cx="388208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b="1" dirty="0"/>
              <a:t>Hydrop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631E11F-566C-AF1D-6DA6-0C36B5B7DBF7}"/>
              </a:ext>
            </a:extLst>
          </p:cNvPr>
          <p:cNvSpPr txBox="1"/>
          <p:nvPr/>
        </p:nvSpPr>
        <p:spPr>
          <a:xfrm>
            <a:off x="111032" y="8752571"/>
            <a:ext cx="6435716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/>
              <a:t>Figure S2. (Continued)</a:t>
            </a:r>
          </a:p>
        </p:txBody>
      </p:sp>
    </p:spTree>
    <p:extLst>
      <p:ext uri="{BB962C8B-B14F-4D97-AF65-F5344CB8AC3E}">
        <p14:creationId xmlns:p14="http://schemas.microsoft.com/office/powerpoint/2010/main" val="20463028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>
            <a:extLst>
              <a:ext uri="{FF2B5EF4-FFF2-40B4-BE49-F238E27FC236}">
                <a16:creationId xmlns:a16="http://schemas.microsoft.com/office/drawing/2014/main" id="{ABF966D6-7074-6D2C-9C10-47285EEB9FE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rcRect r="6757"/>
          <a:stretch>
            <a:fillRect/>
          </a:stretch>
        </p:blipFill>
        <p:spPr>
          <a:xfrm>
            <a:off x="92843" y="475067"/>
            <a:ext cx="6682187" cy="7352282"/>
          </a:xfrm>
          <a:prstGeom prst="rect">
            <a:avLst/>
          </a:prstGeom>
        </p:spPr>
      </p:pic>
      <p:pic>
        <p:nvPicPr>
          <p:cNvPr id="3" name="Picture 2" descr="A graph with numbers and lines&#10;&#10;AI-generated content may be incorrect.">
            <a:extLst>
              <a:ext uri="{FF2B5EF4-FFF2-40B4-BE49-F238E27FC236}">
                <a16:creationId xmlns:a16="http://schemas.microsoft.com/office/drawing/2014/main" id="{C4FCEE56-73ED-1E0D-12DC-E7D7D964FAA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7600"/>
          <a:stretch>
            <a:fillRect/>
          </a:stretch>
        </p:blipFill>
        <p:spPr>
          <a:xfrm>
            <a:off x="0" y="7984799"/>
            <a:ext cx="6743946" cy="239364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2C548AE-6F40-BDF9-6371-6C839D586AA1}"/>
              </a:ext>
            </a:extLst>
          </p:cNvPr>
          <p:cNvSpPr txBox="1"/>
          <p:nvPr/>
        </p:nvSpPr>
        <p:spPr>
          <a:xfrm>
            <a:off x="54864" y="456779"/>
            <a:ext cx="388208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b="1" dirty="0"/>
              <a:t>Skeleta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0268D51-D989-5FA8-AF56-0921E2977AD3}"/>
              </a:ext>
            </a:extLst>
          </p:cNvPr>
          <p:cNvSpPr txBox="1"/>
          <p:nvPr/>
        </p:nvSpPr>
        <p:spPr>
          <a:xfrm>
            <a:off x="-11837" y="7827349"/>
            <a:ext cx="388208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b="1"/>
              <a:t>Respiratory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23DB02F-CC1B-DCE2-70DD-679EA95A0F86}"/>
              </a:ext>
            </a:extLst>
          </p:cNvPr>
          <p:cNvSpPr txBox="1"/>
          <p:nvPr/>
        </p:nvSpPr>
        <p:spPr>
          <a:xfrm>
            <a:off x="59077" y="10380480"/>
            <a:ext cx="6435716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/>
              <a:t>Figure S2. (Continued)</a:t>
            </a:r>
          </a:p>
        </p:txBody>
      </p:sp>
    </p:spTree>
    <p:extLst>
      <p:ext uri="{BB962C8B-B14F-4D97-AF65-F5344CB8AC3E}">
        <p14:creationId xmlns:p14="http://schemas.microsoft.com/office/powerpoint/2010/main" val="30567444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A close-up of a graph&#10;&#10;AI-generated content may be incorrect.">
            <a:extLst>
              <a:ext uri="{FF2B5EF4-FFF2-40B4-BE49-F238E27FC236}">
                <a16:creationId xmlns:a16="http://schemas.microsoft.com/office/drawing/2014/main" id="{2D588369-9556-6429-8918-92CD807BCFD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rcRect t="13556" r="9200" b="10256"/>
          <a:stretch>
            <a:fillRect/>
          </a:stretch>
        </p:blipFill>
        <p:spPr>
          <a:xfrm>
            <a:off x="0" y="621130"/>
            <a:ext cx="6751917" cy="606766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ECBF59C-1AB0-50C4-6F75-47BCA5211B18}"/>
              </a:ext>
            </a:extLst>
          </p:cNvPr>
          <p:cNvSpPr txBox="1"/>
          <p:nvPr/>
        </p:nvSpPr>
        <p:spPr>
          <a:xfrm>
            <a:off x="106083" y="377361"/>
            <a:ext cx="388208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b="1" dirty="0"/>
              <a:t>CAKUT</a:t>
            </a:r>
          </a:p>
        </p:txBody>
      </p:sp>
      <p:pic>
        <p:nvPicPr>
          <p:cNvPr id="3" name="Picture 2" descr="A graph of a number of numbers&#10;&#10;AI-generated content may be incorrect.">
            <a:extLst>
              <a:ext uri="{FF2B5EF4-FFF2-40B4-BE49-F238E27FC236}">
                <a16:creationId xmlns:a16="http://schemas.microsoft.com/office/drawing/2014/main" id="{B41D7585-8076-F82F-5F96-ED03D89DEE3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066"/>
          <a:stretch>
            <a:fillRect/>
          </a:stretch>
        </p:blipFill>
        <p:spPr>
          <a:xfrm>
            <a:off x="58711" y="6932562"/>
            <a:ext cx="6693206" cy="362875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037A7B3-E465-7D90-88A3-359E403F79CA}"/>
              </a:ext>
            </a:extLst>
          </p:cNvPr>
          <p:cNvSpPr txBox="1"/>
          <p:nvPr/>
        </p:nvSpPr>
        <p:spPr>
          <a:xfrm>
            <a:off x="160947" y="7024821"/>
            <a:ext cx="388208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b="1" dirty="0"/>
              <a:t>Gastrointestina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AA2E8E2-2877-6F99-840A-92D1DE6B38D9}"/>
              </a:ext>
            </a:extLst>
          </p:cNvPr>
          <p:cNvSpPr txBox="1"/>
          <p:nvPr/>
        </p:nvSpPr>
        <p:spPr>
          <a:xfrm>
            <a:off x="111032" y="10432435"/>
            <a:ext cx="6435716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/>
              <a:t>Figure S2. (Continued)</a:t>
            </a:r>
          </a:p>
        </p:txBody>
      </p:sp>
    </p:spTree>
    <p:extLst>
      <p:ext uri="{BB962C8B-B14F-4D97-AF65-F5344CB8AC3E}">
        <p14:creationId xmlns:p14="http://schemas.microsoft.com/office/powerpoint/2010/main" val="32485428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diagram of funnel plot&#10;&#10;AI-generated content may be incorrect.">
            <a:extLst>
              <a:ext uri="{FF2B5EF4-FFF2-40B4-BE49-F238E27FC236}">
                <a16:creationId xmlns:a16="http://schemas.microsoft.com/office/drawing/2014/main" id="{B2000ACB-A08A-0E55-E409-8B8E0E7DC86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422" y="311944"/>
            <a:ext cx="5915025" cy="4732020"/>
          </a:xfr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07D6CB8-ABD6-DBE6-CE65-E70A38330A45}"/>
              </a:ext>
            </a:extLst>
          </p:cNvPr>
          <p:cNvSpPr txBox="1"/>
          <p:nvPr/>
        </p:nvSpPr>
        <p:spPr>
          <a:xfrm>
            <a:off x="0" y="5043964"/>
            <a:ext cx="6435716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US" sz="1200" dirty="0"/>
              <a:t>Figure S3. </a:t>
            </a:r>
            <a:r>
              <a:rPr lang="en-GB" sz="1200" dirty="0"/>
              <a:t>Funnel plot of included studies demonstrating incremental diagnostic yield against standard error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333622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bddef00a-e69d-49f8-978d-57a1a03a867b}" enabled="0" method="" siteId="{bddef00a-e69d-49f8-978d-57a1a03a867b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</TotalTime>
  <Words>122</Words>
  <Application>Microsoft Office PowerPoint</Application>
  <PresentationFormat>Widescreen</PresentationFormat>
  <Paragraphs>20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ren lim</dc:creator>
  <cp:lastModifiedBy>karen lim</cp:lastModifiedBy>
  <cp:revision>22</cp:revision>
  <dcterms:created xsi:type="dcterms:W3CDTF">2025-10-03T22:21:40Z</dcterms:created>
  <dcterms:modified xsi:type="dcterms:W3CDTF">2026-02-21T03:45:51Z</dcterms:modified>
</cp:coreProperties>
</file>